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5.png" ContentType="image/png"/>
  <Override PartName="/ppt/media/image10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907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F76212-0853-4ACB-B927-2A2D95374F1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789EE3-C1AF-4D0D-B34E-4ECC679CF77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82E4A7-8A6E-4231-8A75-7411BEBC2B6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0964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52428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9500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0964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52428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7F7A1B-AB71-43D2-A059-86EFC56CA69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018314-043A-47D9-8137-8069360208F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A26D79-24F1-4BE7-8F6C-109E82A290D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EC0BF0-2515-4231-B327-AC64ABC94E0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7D013F-4415-4F21-B201-3F407E7F4C7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95000" y="274320"/>
            <a:ext cx="8915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745088-7FFB-4BEA-B14C-42A13B47187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D16934-6A9F-4E24-B411-D26DE7E48DC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6421BD-7924-4D87-8191-F9B9DE7F00B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8E03A9-D202-4293-AAEC-07B3349CD51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5360" y="6244920"/>
            <a:ext cx="231120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384360" y="6244920"/>
            <a:ext cx="313668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098840" y="6244920"/>
            <a:ext cx="231156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993102A-D775-4E3C-9B16-BEFF75E06E40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1.jpe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1.jpeg"/><Relationship Id="rId6" Type="http://schemas.openxmlformats.org/officeDocument/2006/relationships/image" Target="../media/image4.png"/><Relationship Id="rId7" Type="http://schemas.openxmlformats.org/officeDocument/2006/relationships/image" Target="../media/image5.png"/><Relationship Id="rId8" Type="http://schemas.openxmlformats.org/officeDocument/2006/relationships/image" Target="../media/image6.png"/><Relationship Id="rId9" Type="http://schemas.openxmlformats.org/officeDocument/2006/relationships/image" Target="../media/image7.png"/><Relationship Id="rId10" Type="http://schemas.openxmlformats.org/officeDocument/2006/relationships/image" Target="../media/image8.png"/><Relationship Id="rId11" Type="http://schemas.openxmlformats.org/officeDocument/2006/relationships/image" Target="../media/image9.png"/><Relationship Id="rId12" Type="http://schemas.openxmlformats.org/officeDocument/2006/relationships/image" Target="../media/image10.png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4"/>
          <p:cNvSpPr/>
          <p:nvPr/>
        </p:nvSpPr>
        <p:spPr>
          <a:xfrm>
            <a:off x="7080120" y="1308240"/>
            <a:ext cx="172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  <a:ea typeface="Calibri"/>
              </a:rPr>
              <a:t>P-ERK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5"/>
          <p:cNvSpPr/>
          <p:nvPr/>
        </p:nvSpPr>
        <p:spPr>
          <a:xfrm>
            <a:off x="7066080" y="1566720"/>
            <a:ext cx="172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  <a:ea typeface="Calibri"/>
              </a:rPr>
              <a:t>Total ERK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6"/>
          <p:cNvSpPr/>
          <p:nvPr/>
        </p:nvSpPr>
        <p:spPr>
          <a:xfrm>
            <a:off x="7094520" y="1998720"/>
            <a:ext cx="172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  <a:ea typeface="Calibri"/>
              </a:rPr>
              <a:t>P-JNK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7"/>
          <p:cNvSpPr/>
          <p:nvPr/>
        </p:nvSpPr>
        <p:spPr>
          <a:xfrm>
            <a:off x="7074000" y="2492280"/>
            <a:ext cx="172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  <a:ea typeface="Calibri"/>
              </a:rPr>
              <a:t>Total JNK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8"/>
          <p:cNvSpPr/>
          <p:nvPr/>
        </p:nvSpPr>
        <p:spPr>
          <a:xfrm>
            <a:off x="7080120" y="2933640"/>
            <a:ext cx="172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  <a:ea typeface="Calibri"/>
              </a:rPr>
              <a:t>P-p3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9"/>
          <p:cNvSpPr/>
          <p:nvPr/>
        </p:nvSpPr>
        <p:spPr>
          <a:xfrm>
            <a:off x="7064280" y="3236760"/>
            <a:ext cx="172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  <a:ea typeface="Calibri"/>
              </a:rPr>
              <a:t>Total p3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10"/>
          <p:cNvSpPr/>
          <p:nvPr/>
        </p:nvSpPr>
        <p:spPr>
          <a:xfrm>
            <a:off x="7094520" y="3524400"/>
            <a:ext cx="172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  <a:ea typeface="Calibri"/>
              </a:rPr>
              <a:t>P-STAT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11"/>
          <p:cNvSpPr/>
          <p:nvPr/>
        </p:nvSpPr>
        <p:spPr>
          <a:xfrm>
            <a:off x="7094520" y="4013280"/>
            <a:ext cx="647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  <a:ea typeface="Calibri"/>
              </a:rPr>
              <a:t>BAX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12"/>
          <p:cNvSpPr/>
          <p:nvPr/>
        </p:nvSpPr>
        <p:spPr>
          <a:xfrm>
            <a:off x="7094520" y="4286160"/>
            <a:ext cx="172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  <a:ea typeface="Calibri"/>
              </a:rPr>
              <a:t>BCL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13"/>
          <p:cNvSpPr/>
          <p:nvPr/>
        </p:nvSpPr>
        <p:spPr>
          <a:xfrm>
            <a:off x="6935760" y="4618080"/>
            <a:ext cx="172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  <a:ea typeface="Calibri"/>
              </a:rPr>
              <a:t>P-pRB 79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14"/>
          <p:cNvSpPr/>
          <p:nvPr/>
        </p:nvSpPr>
        <p:spPr>
          <a:xfrm>
            <a:off x="7094520" y="4948200"/>
            <a:ext cx="172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  <a:ea typeface="Calibri"/>
              </a:rPr>
              <a:t>Total pR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15"/>
          <p:cNvSpPr/>
          <p:nvPr/>
        </p:nvSpPr>
        <p:spPr>
          <a:xfrm>
            <a:off x="7095960" y="5207040"/>
            <a:ext cx="172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  <a:ea typeface="Calibri"/>
              </a:rPr>
              <a:t>P-Cre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16"/>
          <p:cNvSpPr/>
          <p:nvPr/>
        </p:nvSpPr>
        <p:spPr>
          <a:xfrm>
            <a:off x="7083360" y="5424480"/>
            <a:ext cx="172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  <a:ea typeface="Calibri"/>
              </a:rPr>
              <a:t>GAPD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4" name="Picture 17" descr=""/>
          <p:cNvPicPr/>
          <p:nvPr/>
        </p:nvPicPr>
        <p:blipFill>
          <a:blip r:embed="rId1"/>
          <a:srcRect l="0" t="41006" r="36641" b="42967"/>
          <a:stretch/>
        </p:blipFill>
        <p:spPr>
          <a:xfrm>
            <a:off x="5769000" y="3208320"/>
            <a:ext cx="1400040" cy="647640"/>
          </a:xfrm>
          <a:prstGeom prst="rect">
            <a:avLst/>
          </a:prstGeom>
          <a:ln w="0">
            <a:noFill/>
          </a:ln>
        </p:spPr>
      </p:pic>
      <p:pic>
        <p:nvPicPr>
          <p:cNvPr id="55" name="Picture 18" descr=""/>
          <p:cNvPicPr/>
          <p:nvPr/>
        </p:nvPicPr>
        <p:blipFill>
          <a:blip r:embed="rId2"/>
          <a:srcRect l="0" t="0" r="36641" b="59003"/>
          <a:stretch/>
        </p:blipFill>
        <p:spPr>
          <a:xfrm>
            <a:off x="5769000" y="1263600"/>
            <a:ext cx="1400040" cy="165564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19" descr=""/>
          <p:cNvPicPr/>
          <p:nvPr/>
        </p:nvPicPr>
        <p:blipFill>
          <a:blip r:embed="rId3"/>
          <a:stretch/>
        </p:blipFill>
        <p:spPr>
          <a:xfrm>
            <a:off x="5856120" y="2984400"/>
            <a:ext cx="1258920" cy="19836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20" descr=""/>
          <p:cNvPicPr/>
          <p:nvPr/>
        </p:nvPicPr>
        <p:blipFill>
          <a:blip r:embed="rId4"/>
          <a:stretch/>
        </p:blipFill>
        <p:spPr>
          <a:xfrm>
            <a:off x="5853240" y="3848040"/>
            <a:ext cx="1288800" cy="16344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21" descr=""/>
          <p:cNvPicPr/>
          <p:nvPr/>
        </p:nvPicPr>
        <p:blipFill>
          <a:blip r:embed="rId5"/>
          <a:srcRect l="0" t="57042" r="36641" b="0"/>
          <a:stretch/>
        </p:blipFill>
        <p:spPr>
          <a:xfrm>
            <a:off x="5783400" y="4029120"/>
            <a:ext cx="1400040" cy="1735200"/>
          </a:xfrm>
          <a:prstGeom prst="rect">
            <a:avLst/>
          </a:prstGeom>
          <a:ln w="0">
            <a:noFill/>
          </a:ln>
        </p:spPr>
      </p:pic>
      <p:sp>
        <p:nvSpPr>
          <p:cNvPr id="59" name="Text Box 22"/>
          <p:cNvSpPr/>
          <p:nvPr/>
        </p:nvSpPr>
        <p:spPr>
          <a:xfrm>
            <a:off x="7081920" y="3797280"/>
            <a:ext cx="172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  <a:ea typeface="Calibri"/>
              </a:rPr>
              <a:t>P-STAT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23"/>
          <p:cNvSpPr/>
          <p:nvPr/>
        </p:nvSpPr>
        <p:spPr>
          <a:xfrm>
            <a:off x="6105600" y="5877000"/>
            <a:ext cx="1584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  <a:ea typeface="Calibri"/>
              </a:rPr>
              <a:t>PANC-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24"/>
          <p:cNvSpPr/>
          <p:nvPr/>
        </p:nvSpPr>
        <p:spPr>
          <a:xfrm>
            <a:off x="5769000" y="1407960"/>
            <a:ext cx="0" cy="20876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25"/>
          <p:cNvSpPr/>
          <p:nvPr/>
        </p:nvSpPr>
        <p:spPr>
          <a:xfrm>
            <a:off x="4978440" y="2343240"/>
            <a:ext cx="792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  <a:ea typeface="Calibri"/>
              </a:rPr>
              <a:t>MAPK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26"/>
          <p:cNvSpPr/>
          <p:nvPr/>
        </p:nvSpPr>
        <p:spPr>
          <a:xfrm>
            <a:off x="5049720" y="3639960"/>
            <a:ext cx="792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  <a:ea typeface="Calibri"/>
              </a:rPr>
              <a:t>STAT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27"/>
          <p:cNvSpPr/>
          <p:nvPr/>
        </p:nvSpPr>
        <p:spPr>
          <a:xfrm>
            <a:off x="5781600" y="3597120"/>
            <a:ext cx="0" cy="4320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28"/>
          <p:cNvSpPr/>
          <p:nvPr/>
        </p:nvSpPr>
        <p:spPr>
          <a:xfrm>
            <a:off x="4840200" y="4145040"/>
            <a:ext cx="1152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  <a:ea typeface="Calibri"/>
              </a:rPr>
              <a:t>Apoptosi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29"/>
          <p:cNvSpPr/>
          <p:nvPr/>
        </p:nvSpPr>
        <p:spPr>
          <a:xfrm>
            <a:off x="5789520" y="4102200"/>
            <a:ext cx="0" cy="4316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7" name="Picture 30" descr=""/>
          <p:cNvPicPr/>
          <p:nvPr/>
        </p:nvPicPr>
        <p:blipFill>
          <a:blip r:embed="rId6"/>
          <a:stretch/>
        </p:blipFill>
        <p:spPr>
          <a:xfrm>
            <a:off x="1757520" y="1363680"/>
            <a:ext cx="1352520" cy="209520"/>
          </a:xfrm>
          <a:prstGeom prst="rect">
            <a:avLst/>
          </a:prstGeom>
          <a:ln w="0">
            <a:noFill/>
          </a:ln>
        </p:spPr>
      </p:pic>
      <p:pic>
        <p:nvPicPr>
          <p:cNvPr id="68" name="Picture 31" descr=""/>
          <p:cNvPicPr/>
          <p:nvPr/>
        </p:nvPicPr>
        <p:blipFill>
          <a:blip r:embed="rId7"/>
          <a:stretch/>
        </p:blipFill>
        <p:spPr>
          <a:xfrm>
            <a:off x="1771560" y="1565280"/>
            <a:ext cx="1314720" cy="219240"/>
          </a:xfrm>
          <a:prstGeom prst="rect">
            <a:avLst/>
          </a:prstGeom>
          <a:ln w="0">
            <a:noFill/>
          </a:ln>
        </p:spPr>
      </p:pic>
      <p:sp>
        <p:nvSpPr>
          <p:cNvPr id="69" name="Text Box 32"/>
          <p:cNvSpPr/>
          <p:nvPr/>
        </p:nvSpPr>
        <p:spPr>
          <a:xfrm>
            <a:off x="3029040" y="1312920"/>
            <a:ext cx="172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  <a:ea typeface="Calibri"/>
              </a:rPr>
              <a:t>P-ERK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33"/>
          <p:cNvSpPr/>
          <p:nvPr/>
        </p:nvSpPr>
        <p:spPr>
          <a:xfrm>
            <a:off x="3030480" y="1528920"/>
            <a:ext cx="172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  <a:ea typeface="Calibri"/>
              </a:rPr>
              <a:t>Total ERK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1" name="Group 34"/>
          <p:cNvGrpSpPr/>
          <p:nvPr/>
        </p:nvGrpSpPr>
        <p:grpSpPr>
          <a:xfrm>
            <a:off x="1755720" y="1922400"/>
            <a:ext cx="2998800" cy="938880"/>
            <a:chOff x="1755720" y="1922400"/>
            <a:chExt cx="2998800" cy="938880"/>
          </a:xfrm>
        </p:grpSpPr>
        <p:pic>
          <p:nvPicPr>
            <p:cNvPr id="72" name="Picture 35" descr=""/>
            <p:cNvPicPr/>
            <p:nvPr/>
          </p:nvPicPr>
          <p:blipFill>
            <a:blip r:embed="rId8"/>
            <a:srcRect l="0" t="0" r="7993" b="21932"/>
            <a:stretch/>
          </p:blipFill>
          <p:spPr>
            <a:xfrm>
              <a:off x="1755720" y="1951200"/>
              <a:ext cx="1297080" cy="21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3" name="Picture 36" descr=""/>
            <p:cNvPicPr/>
            <p:nvPr/>
          </p:nvPicPr>
          <p:blipFill>
            <a:blip r:embed="rId9"/>
            <a:srcRect l="0" t="0" r="9815" b="-2921"/>
            <a:stretch/>
          </p:blipFill>
          <p:spPr>
            <a:xfrm>
              <a:off x="1755720" y="2270160"/>
              <a:ext cx="1297080" cy="21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4" name="Picture 37" descr=""/>
            <p:cNvPicPr/>
            <p:nvPr/>
          </p:nvPicPr>
          <p:blipFill>
            <a:blip r:embed="rId10"/>
            <a:stretch/>
          </p:blipFill>
          <p:spPr>
            <a:xfrm>
              <a:off x="1793880" y="2533680"/>
              <a:ext cx="1295280" cy="314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5" name="Text Box 38"/>
            <p:cNvSpPr/>
            <p:nvPr/>
          </p:nvSpPr>
          <p:spPr>
            <a:xfrm>
              <a:off x="3009960" y="1922400"/>
              <a:ext cx="1728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400" spc="-1" strike="noStrike">
                  <a:solidFill>
                    <a:srgbClr val="000000"/>
                  </a:solidFill>
                  <a:latin typeface="Calibri"/>
                  <a:ea typeface="Calibri"/>
                </a:rPr>
                <a:t>P-STAT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Text Box 39"/>
            <p:cNvSpPr/>
            <p:nvPr/>
          </p:nvSpPr>
          <p:spPr>
            <a:xfrm>
              <a:off x="3011400" y="2266920"/>
              <a:ext cx="1728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400" spc="-1" strike="noStrike">
                  <a:solidFill>
                    <a:srgbClr val="000000"/>
                  </a:solidFill>
                  <a:latin typeface="Calibri"/>
                  <a:ea typeface="Calibri"/>
                </a:rPr>
                <a:t>P-STAT3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Text Box 40"/>
            <p:cNvSpPr/>
            <p:nvPr/>
          </p:nvSpPr>
          <p:spPr>
            <a:xfrm>
              <a:off x="3025800" y="2554200"/>
              <a:ext cx="1728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400" spc="-1" strike="noStrike">
                  <a:solidFill>
                    <a:srgbClr val="000000"/>
                  </a:solidFill>
                  <a:latin typeface="Calibri"/>
                  <a:ea typeface="Calibri"/>
                </a:rPr>
                <a:t>GAPDH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8" name="Line 41"/>
          <p:cNvSpPr/>
          <p:nvPr/>
        </p:nvSpPr>
        <p:spPr>
          <a:xfrm>
            <a:off x="1717560" y="1905120"/>
            <a:ext cx="0" cy="93636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Line 42"/>
          <p:cNvSpPr/>
          <p:nvPr/>
        </p:nvSpPr>
        <p:spPr>
          <a:xfrm>
            <a:off x="1717560" y="1343160"/>
            <a:ext cx="0" cy="4316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43"/>
          <p:cNvSpPr/>
          <p:nvPr/>
        </p:nvSpPr>
        <p:spPr>
          <a:xfrm>
            <a:off x="954000" y="1387440"/>
            <a:ext cx="792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  <a:ea typeface="Calibri"/>
              </a:rPr>
              <a:t>MAPK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44"/>
          <p:cNvSpPr/>
          <p:nvPr/>
        </p:nvSpPr>
        <p:spPr>
          <a:xfrm>
            <a:off x="1011240" y="2208240"/>
            <a:ext cx="792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  <a:ea typeface="Calibri"/>
              </a:rPr>
              <a:t>STAT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45"/>
          <p:cNvSpPr/>
          <p:nvPr/>
        </p:nvSpPr>
        <p:spPr>
          <a:xfrm>
            <a:off x="2144880" y="2997360"/>
            <a:ext cx="1584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  <a:ea typeface="Calibri"/>
              </a:rPr>
              <a:t>BxPC-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46"/>
          <p:cNvSpPr/>
          <p:nvPr/>
        </p:nvSpPr>
        <p:spPr>
          <a:xfrm rot="18486000">
            <a:off x="1662120" y="392040"/>
            <a:ext cx="1376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  <a:ea typeface="Calibri"/>
              </a:rPr>
              <a:t>CTR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47"/>
          <p:cNvSpPr/>
          <p:nvPr/>
        </p:nvSpPr>
        <p:spPr>
          <a:xfrm rot="18486000">
            <a:off x="1932840" y="192960"/>
            <a:ext cx="1832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  <a:ea typeface="Calibri"/>
              </a:rPr>
              <a:t>FGFR3-III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48"/>
          <p:cNvSpPr/>
          <p:nvPr/>
        </p:nvSpPr>
        <p:spPr>
          <a:xfrm rot="18486000">
            <a:off x="2332080" y="163440"/>
            <a:ext cx="1833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  <a:ea typeface="Calibri"/>
              </a:rPr>
              <a:t>FGFR3-III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6" name="Group 49"/>
          <p:cNvGrpSpPr/>
          <p:nvPr/>
        </p:nvGrpSpPr>
        <p:grpSpPr>
          <a:xfrm>
            <a:off x="5899320" y="-500400"/>
            <a:ext cx="2130480" cy="1680840"/>
            <a:chOff x="5899320" y="-500400"/>
            <a:chExt cx="2130480" cy="1680840"/>
          </a:xfrm>
        </p:grpSpPr>
        <p:sp>
          <p:nvSpPr>
            <p:cNvPr id="87" name="Text Box 50"/>
            <p:cNvSpPr/>
            <p:nvPr/>
          </p:nvSpPr>
          <p:spPr>
            <a:xfrm rot="18486000">
              <a:off x="5756400" y="390600"/>
              <a:ext cx="13762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400" spc="-1" strike="noStrike">
                  <a:solidFill>
                    <a:srgbClr val="000000"/>
                  </a:solidFill>
                  <a:latin typeface="Calibri"/>
                  <a:ea typeface="Calibri"/>
                </a:rPr>
                <a:t>CTRL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Text Box 51"/>
            <p:cNvSpPr/>
            <p:nvPr/>
          </p:nvSpPr>
          <p:spPr>
            <a:xfrm rot="18486000">
              <a:off x="6026760" y="191520"/>
              <a:ext cx="18316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400" spc="-1" strike="noStrike">
                  <a:solidFill>
                    <a:srgbClr val="000000"/>
                  </a:solidFill>
                  <a:latin typeface="Calibri"/>
                  <a:ea typeface="Calibri"/>
                </a:rPr>
                <a:t>FGFR3-IIIb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Text Box 52"/>
            <p:cNvSpPr/>
            <p:nvPr/>
          </p:nvSpPr>
          <p:spPr>
            <a:xfrm rot="18486000">
              <a:off x="6426360" y="162000"/>
              <a:ext cx="18334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400" spc="-1" strike="noStrike">
                  <a:solidFill>
                    <a:srgbClr val="000000"/>
                  </a:solidFill>
                  <a:latin typeface="Calibri"/>
                  <a:ea typeface="Calibri"/>
                </a:rPr>
                <a:t>FGFR3-IIIc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90" name="Picture 53" descr=""/>
          <p:cNvPicPr/>
          <p:nvPr/>
        </p:nvPicPr>
        <p:blipFill>
          <a:blip r:embed="rId11"/>
          <a:stretch/>
        </p:blipFill>
        <p:spPr>
          <a:xfrm>
            <a:off x="5878440" y="1058760"/>
            <a:ext cx="1224000" cy="209520"/>
          </a:xfrm>
          <a:prstGeom prst="rect">
            <a:avLst/>
          </a:prstGeom>
          <a:ln w="0">
            <a:noFill/>
          </a:ln>
        </p:spPr>
      </p:pic>
      <p:sp>
        <p:nvSpPr>
          <p:cNvPr id="91" name="Text Box 54"/>
          <p:cNvSpPr/>
          <p:nvPr/>
        </p:nvSpPr>
        <p:spPr>
          <a:xfrm>
            <a:off x="7074000" y="1009800"/>
            <a:ext cx="936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  <a:ea typeface="Calibri"/>
              </a:rPr>
              <a:t>FGFR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2" name="Picture 55" descr=""/>
          <p:cNvPicPr/>
          <p:nvPr/>
        </p:nvPicPr>
        <p:blipFill>
          <a:blip r:embed="rId12"/>
          <a:stretch/>
        </p:blipFill>
        <p:spPr>
          <a:xfrm>
            <a:off x="1758960" y="1073160"/>
            <a:ext cx="1297080" cy="200160"/>
          </a:xfrm>
          <a:prstGeom prst="rect">
            <a:avLst/>
          </a:prstGeom>
          <a:ln w="0">
            <a:noFill/>
          </a:ln>
        </p:spPr>
      </p:pic>
      <p:sp>
        <p:nvSpPr>
          <p:cNvPr id="93" name="Text Box 56"/>
          <p:cNvSpPr/>
          <p:nvPr/>
        </p:nvSpPr>
        <p:spPr>
          <a:xfrm>
            <a:off x="3013200" y="1009800"/>
            <a:ext cx="936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  <a:ea typeface="Calibri"/>
              </a:rPr>
              <a:t>FGFR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ZoneTexte 54"/>
          <p:cNvSpPr/>
          <p:nvPr/>
        </p:nvSpPr>
        <p:spPr>
          <a:xfrm>
            <a:off x="1214640" y="6021360"/>
            <a:ext cx="1602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Calibri"/>
                <a:ea typeface="Calibri"/>
              </a:rPr>
              <a:t>Supplemental Figure 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6-13T13:20:30Z</dcterms:created>
  <dc:creator>Mélois</dc:creator>
  <dc:description/>
  <dc:language>en-US</dc:language>
  <cp:lastModifiedBy>Sandrine</cp:lastModifiedBy>
  <dcterms:modified xsi:type="dcterms:W3CDTF">2013-06-17T15:06:14Z</dcterms:modified>
  <cp:revision>3</cp:revision>
  <dc:subject/>
  <dc:title>Diapositive 1</dc:title>
</cp:coreProperties>
</file>